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6" r:id="rId2"/>
  </p:sldIdLst>
  <p:sldSz cx="6858000" cy="97202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6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DCACA"/>
    <a:srgbClr val="FFC003"/>
    <a:srgbClr val="92D1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09"/>
    <p:restoredTop sz="75493"/>
  </p:normalViewPr>
  <p:slideViewPr>
    <p:cSldViewPr snapToGrid="0" snapToObjects="1" showGuides="1">
      <p:cViewPr varScale="1">
        <p:scale>
          <a:sx n="59" d="100"/>
          <a:sy n="59" d="100"/>
        </p:scale>
        <p:origin x="3896" y="200"/>
      </p:cViewPr>
      <p:guideLst>
        <p:guide orient="horz" pos="306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2099F8-9646-E445-8905-8EA8EB14A08B}" type="datetimeFigureOut">
              <a:rPr lang="en-US" smtClean="0"/>
              <a:t>6/1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9975" y="1143000"/>
            <a:ext cx="2178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31D2A7-18B6-6D43-AFFD-3A8201D9A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336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l Figure S5: </a:t>
            </a:r>
            <a:r>
              <a:rPr lang="en-CA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utcome comparisons of patients from studies with high versus low/moderate risk of bias (ROB). A) Overall response rate in patients from studies with low/moderate (ROB score 4-5) versus high (ROB score 0-3) risk of bias. B) Progression-free survival in patients from studies with low/moderate (ROB score 4-5) versus high (ROB score 0-3) risk of bias. C) Overall survival in patients from studies with low/moderate (ROB score 4-5) versus high (ROB score 0-3) risk of bias. P-values calculated with Fischer’s Exact Test in A, and with log-rank test in B and C.</a:t>
            </a:r>
            <a:endParaRPr lang="en-CA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indent="0" algn="just">
              <a:buFontTx/>
              <a:buNone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231D2A7-18B6-6D43-AFFD-3A8201D9A7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72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590794"/>
            <a:ext cx="5829300" cy="338409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105389"/>
            <a:ext cx="5143500" cy="234681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17514"/>
            <a:ext cx="1478756" cy="823747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17514"/>
            <a:ext cx="4350544" cy="823747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23318"/>
            <a:ext cx="5915025" cy="404335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504929"/>
            <a:ext cx="5915025" cy="212630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587570"/>
            <a:ext cx="2914650" cy="61674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587570"/>
            <a:ext cx="2914650" cy="616741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7516"/>
            <a:ext cx="5915025" cy="1878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382815"/>
            <a:ext cx="2901255" cy="116778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550596"/>
            <a:ext cx="2901255" cy="5222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382815"/>
            <a:ext cx="2915543" cy="116778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550596"/>
            <a:ext cx="2915543" cy="5222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8018"/>
            <a:ext cx="2211884" cy="226806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99540"/>
            <a:ext cx="3471863" cy="690768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16079"/>
            <a:ext cx="2211884" cy="540239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8018"/>
            <a:ext cx="2211884" cy="226806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99540"/>
            <a:ext cx="3471863" cy="690768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16079"/>
            <a:ext cx="2211884" cy="540239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17516"/>
            <a:ext cx="5915025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587570"/>
            <a:ext cx="5915025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009246"/>
            <a:ext cx="154305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B61884-E82D-4946-86B2-2FCA2EA00FDA}" type="datetimeFigureOut">
              <a:rPr lang="en-US" smtClean="0"/>
              <a:t>6/1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009246"/>
            <a:ext cx="2314575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009246"/>
            <a:ext cx="154305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C8E5C-05AF-B94E-A20D-C1820B1861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381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6" name="Group 255">
            <a:extLst>
              <a:ext uri="{FF2B5EF4-FFF2-40B4-BE49-F238E27FC236}">
                <a16:creationId xmlns:a16="http://schemas.microsoft.com/office/drawing/2014/main" id="{FBDC6257-1C84-A54B-ACB9-D83D322EC52F}"/>
              </a:ext>
            </a:extLst>
          </p:cNvPr>
          <p:cNvGrpSpPr/>
          <p:nvPr/>
        </p:nvGrpSpPr>
        <p:grpSpPr>
          <a:xfrm>
            <a:off x="882661" y="-6215"/>
            <a:ext cx="6127735" cy="9759817"/>
            <a:chOff x="-104993" y="167954"/>
            <a:chExt cx="4576178" cy="6836316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63DB8B99-CF51-F8C7-1418-6493F9C07D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654" t="9249" r="2399" b="34636"/>
            <a:stretch/>
          </p:blipFill>
          <p:spPr>
            <a:xfrm>
              <a:off x="650594" y="4630999"/>
              <a:ext cx="2145431" cy="15355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F0032C49-1B72-71F5-2889-51F0F8DFBB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3518" t="10474" r="2221" b="36290"/>
            <a:stretch/>
          </p:blipFill>
          <p:spPr>
            <a:xfrm>
              <a:off x="627003" y="2078302"/>
              <a:ext cx="2181232" cy="146011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EE0180B2-C012-956B-CAAA-B8BBB4F8DC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455" t="15519" r="51734" b="23933"/>
            <a:stretch/>
          </p:blipFill>
          <p:spPr>
            <a:xfrm>
              <a:off x="886273" y="622553"/>
              <a:ext cx="963794" cy="968736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D3A1AE8-57E6-E24A-B0A8-81B6FC2CBE6E}"/>
                </a:ext>
              </a:extLst>
            </p:cNvPr>
            <p:cNvSpPr txBox="1"/>
            <p:nvPr/>
          </p:nvSpPr>
          <p:spPr>
            <a:xfrm>
              <a:off x="-95317" y="167954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31B37F1D-3F9C-1938-76BA-2E070EE522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1439" t="15519" r="4751" b="23933"/>
            <a:stretch/>
          </p:blipFill>
          <p:spPr>
            <a:xfrm>
              <a:off x="1870318" y="610357"/>
              <a:ext cx="963794" cy="968736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C2BB2B6-BACE-814B-F21E-7AFE8526D9E8}"/>
                </a:ext>
              </a:extLst>
            </p:cNvPr>
            <p:cNvSpPr txBox="1"/>
            <p:nvPr/>
          </p:nvSpPr>
          <p:spPr>
            <a:xfrm>
              <a:off x="1437540" y="192755"/>
              <a:ext cx="8595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OB Score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52CB933-CEA2-B097-A38C-1EEDD1BC80CD}"/>
                </a:ext>
              </a:extLst>
            </p:cNvPr>
            <p:cNvSpPr txBox="1"/>
            <p:nvPr/>
          </p:nvSpPr>
          <p:spPr>
            <a:xfrm>
              <a:off x="1189575" y="390620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-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EEDE986-D7F4-D0FA-2A8C-5B6BE241EA09}"/>
                </a:ext>
              </a:extLst>
            </p:cNvPr>
            <p:cNvSpPr txBox="1"/>
            <p:nvPr/>
          </p:nvSpPr>
          <p:spPr>
            <a:xfrm>
              <a:off x="2171337" y="389865"/>
              <a:ext cx="3690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-5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C083F896-7019-5725-6F6F-9DB4AE475D18}"/>
                </a:ext>
              </a:extLst>
            </p:cNvPr>
            <p:cNvGrpSpPr/>
            <p:nvPr/>
          </p:nvGrpSpPr>
          <p:grpSpPr>
            <a:xfrm>
              <a:off x="0" y="1660853"/>
              <a:ext cx="4471185" cy="2758993"/>
              <a:chOff x="-90332" y="1647244"/>
              <a:chExt cx="4471185" cy="2758993"/>
            </a:xfrm>
          </p:grpSpPr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2CD75F68-E50F-DFF6-9037-4933887AB796}"/>
                  </a:ext>
                </a:extLst>
              </p:cNvPr>
              <p:cNvGrpSpPr/>
              <p:nvPr/>
            </p:nvGrpSpPr>
            <p:grpSpPr>
              <a:xfrm>
                <a:off x="11269" y="1647244"/>
                <a:ext cx="3014765" cy="2378023"/>
                <a:chOff x="545529" y="91760"/>
                <a:chExt cx="3844545" cy="2378023"/>
              </a:xfrm>
            </p:grpSpPr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CEA7C90F-ECF9-7438-F392-C32308B24525}"/>
                    </a:ext>
                  </a:extLst>
                </p:cNvPr>
                <p:cNvSpPr txBox="1"/>
                <p:nvPr/>
              </p:nvSpPr>
              <p:spPr>
                <a:xfrm>
                  <a:off x="1914691" y="297827"/>
                  <a:ext cx="11961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hole Cohort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90A9884C-4DCD-1DA5-37E3-5512AC88DDC5}"/>
                    </a:ext>
                  </a:extLst>
                </p:cNvPr>
                <p:cNvSpPr txBox="1"/>
                <p:nvPr/>
              </p:nvSpPr>
              <p:spPr>
                <a:xfrm rot="16200000">
                  <a:off x="-435830" y="1073119"/>
                  <a:ext cx="22397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gression-Free Survival (%)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2C513F8B-1AA8-9D60-2B2D-794018E7C94C}"/>
                    </a:ext>
                  </a:extLst>
                </p:cNvPr>
                <p:cNvSpPr txBox="1"/>
                <p:nvPr/>
              </p:nvSpPr>
              <p:spPr>
                <a:xfrm>
                  <a:off x="807035" y="411011"/>
                  <a:ext cx="4395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8D0F92B6-400A-D92A-7B96-18A795FF1948}"/>
                    </a:ext>
                  </a:extLst>
                </p:cNvPr>
                <p:cNvSpPr txBox="1"/>
                <p:nvPr/>
              </p:nvSpPr>
              <p:spPr>
                <a:xfrm>
                  <a:off x="844292" y="75366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9133897D-223C-D76E-61FF-5E53B8898A6D}"/>
                    </a:ext>
                  </a:extLst>
                </p:cNvPr>
                <p:cNvSpPr txBox="1"/>
                <p:nvPr/>
              </p:nvSpPr>
              <p:spPr>
                <a:xfrm>
                  <a:off x="849512" y="1102123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8BC8CD7B-6045-AFD0-A257-6A3A54212DFD}"/>
                    </a:ext>
                  </a:extLst>
                </p:cNvPr>
                <p:cNvSpPr txBox="1"/>
                <p:nvPr/>
              </p:nvSpPr>
              <p:spPr>
                <a:xfrm>
                  <a:off x="843367" y="145058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66B0A9D4-A629-B1B1-ACBC-8881A4EC53A6}"/>
                    </a:ext>
                  </a:extLst>
                </p:cNvPr>
                <p:cNvSpPr txBox="1"/>
                <p:nvPr/>
              </p:nvSpPr>
              <p:spPr>
                <a:xfrm>
                  <a:off x="891992" y="1799043"/>
                  <a:ext cx="2696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8200E191-36F3-019D-61D4-F4A35586319B}"/>
                    </a:ext>
                  </a:extLst>
                </p:cNvPr>
                <p:cNvSpPr txBox="1"/>
                <p:nvPr/>
              </p:nvSpPr>
              <p:spPr>
                <a:xfrm>
                  <a:off x="1185208" y="1989086"/>
                  <a:ext cx="2696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749DB793-C972-4AE1-3948-004037CEDF3C}"/>
                    </a:ext>
                  </a:extLst>
                </p:cNvPr>
                <p:cNvSpPr txBox="1"/>
                <p:nvPr/>
              </p:nvSpPr>
              <p:spPr>
                <a:xfrm>
                  <a:off x="1994311" y="2006511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BDA91C86-5AC7-011C-EBA5-9A97E04C2936}"/>
                    </a:ext>
                  </a:extLst>
                </p:cNvPr>
                <p:cNvSpPr txBox="1"/>
                <p:nvPr/>
              </p:nvSpPr>
              <p:spPr>
                <a:xfrm>
                  <a:off x="2864528" y="2001435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C9C5BE3B-FE2D-515B-C92D-9BB6C93BA816}"/>
                    </a:ext>
                  </a:extLst>
                </p:cNvPr>
                <p:cNvSpPr txBox="1"/>
                <p:nvPr/>
              </p:nvSpPr>
              <p:spPr>
                <a:xfrm>
                  <a:off x="3626980" y="1996838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B2468FBA-7994-4668-C480-7B76C5CA6642}"/>
                    </a:ext>
                  </a:extLst>
                </p:cNvPr>
                <p:cNvSpPr txBox="1"/>
                <p:nvPr/>
              </p:nvSpPr>
              <p:spPr>
                <a:xfrm>
                  <a:off x="2218856" y="2192784"/>
                  <a:ext cx="68800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nths</a:t>
                  </a:r>
                </a:p>
              </p:txBody>
            </p:sp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C1E27681-A34C-2D60-C07D-F1682D2FCD9F}"/>
                    </a:ext>
                  </a:extLst>
                </p:cNvPr>
                <p:cNvSpPr/>
                <p:nvPr/>
              </p:nvSpPr>
              <p:spPr bwMode="auto">
                <a:xfrm>
                  <a:off x="3649822" y="905859"/>
                  <a:ext cx="157591" cy="142621"/>
                </a:xfrm>
                <a:prstGeom prst="rect">
                  <a:avLst/>
                </a:prstGeom>
                <a:solidFill>
                  <a:srgbClr val="3E637D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ctr" defTabSz="5121275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</a:endParaRPr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CF7B5E8B-C448-61D4-DC91-5A3C8417931A}"/>
                    </a:ext>
                  </a:extLst>
                </p:cNvPr>
                <p:cNvSpPr/>
                <p:nvPr/>
              </p:nvSpPr>
              <p:spPr bwMode="auto">
                <a:xfrm>
                  <a:off x="3649821" y="610540"/>
                  <a:ext cx="157591" cy="142621"/>
                </a:xfrm>
                <a:prstGeom prst="rect">
                  <a:avLst/>
                </a:prstGeom>
                <a:solidFill>
                  <a:srgbClr val="90353A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ctr" defTabSz="5121275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1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charset="0"/>
                  </a:endParaRP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D364B84C-1244-DC54-D045-096B8E131C50}"/>
                    </a:ext>
                  </a:extLst>
                </p:cNvPr>
                <p:cNvSpPr txBox="1"/>
                <p:nvPr/>
              </p:nvSpPr>
              <p:spPr>
                <a:xfrm>
                  <a:off x="2938324" y="889314"/>
                  <a:ext cx="1451750" cy="2797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10000"/>
                    </a:lnSpc>
                  </a:pPr>
                  <a:r>
                    <a:rPr lang="en-US" sz="1200" dirty="0">
                      <a:latin typeface="Arial"/>
                      <a:cs typeface="Arial"/>
                    </a:rPr>
                    <a:t>ROB 0-3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84A35B11-CAB7-7766-F73D-B9257B1B6B9E}"/>
                    </a:ext>
                  </a:extLst>
                </p:cNvPr>
                <p:cNvSpPr txBox="1"/>
                <p:nvPr/>
              </p:nvSpPr>
              <p:spPr>
                <a:xfrm>
                  <a:off x="2932535" y="588267"/>
                  <a:ext cx="1451750" cy="2797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110000"/>
                    </a:lnSpc>
                  </a:pPr>
                  <a:r>
                    <a:rPr lang="en-US" sz="1200" dirty="0">
                      <a:latin typeface="Arial"/>
                      <a:cs typeface="Arial"/>
                    </a:rPr>
                    <a:t>ROB 4-5</a:t>
                  </a:r>
                </a:p>
              </p:txBody>
            </p:sp>
          </p:grp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3A79271-5911-7787-3BA6-5DE4FB34BA8F}"/>
                  </a:ext>
                </a:extLst>
              </p:cNvPr>
              <p:cNvSpPr txBox="1"/>
              <p:nvPr/>
            </p:nvSpPr>
            <p:spPr>
              <a:xfrm>
                <a:off x="-90332" y="3759906"/>
                <a:ext cx="447118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at risk: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OB4-5 13            2               1           1              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OB0-3 21            2               0           0</a:t>
                </a:r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0A31EEF-9107-D2AD-5C8E-FF9B7237D10D}"/>
                </a:ext>
              </a:extLst>
            </p:cNvPr>
            <p:cNvSpPr txBox="1"/>
            <p:nvPr/>
          </p:nvSpPr>
          <p:spPr>
            <a:xfrm>
              <a:off x="1175253" y="4379904"/>
              <a:ext cx="937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hole Cohort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0911161-B9E6-2099-A4DE-690531A02329}"/>
                </a:ext>
              </a:extLst>
            </p:cNvPr>
            <p:cNvSpPr txBox="1"/>
            <p:nvPr/>
          </p:nvSpPr>
          <p:spPr>
            <a:xfrm rot="16200000">
              <a:off x="-560196" y="5226637"/>
              <a:ext cx="15408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%)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852D603F-2010-556D-A154-B6BA8B546CFE}"/>
                </a:ext>
              </a:extLst>
            </p:cNvPr>
            <p:cNvSpPr txBox="1"/>
            <p:nvPr/>
          </p:nvSpPr>
          <p:spPr>
            <a:xfrm>
              <a:off x="306666" y="4621680"/>
              <a:ext cx="3446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E13CDA4-1CFB-D9B7-2F99-8F6D4B838145}"/>
                </a:ext>
              </a:extLst>
            </p:cNvPr>
            <p:cNvSpPr txBox="1"/>
            <p:nvPr/>
          </p:nvSpPr>
          <p:spPr>
            <a:xfrm>
              <a:off x="335881" y="4907181"/>
              <a:ext cx="278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BF88E19E-24EA-DFF6-AB8F-A17A0D582FBA}"/>
                </a:ext>
              </a:extLst>
            </p:cNvPr>
            <p:cNvSpPr txBox="1"/>
            <p:nvPr/>
          </p:nvSpPr>
          <p:spPr>
            <a:xfrm>
              <a:off x="339975" y="5255640"/>
              <a:ext cx="278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F2BB18A-15C5-E00C-E7A7-FD99CBFB096A}"/>
                </a:ext>
              </a:extLst>
            </p:cNvPr>
            <p:cNvSpPr txBox="1"/>
            <p:nvPr/>
          </p:nvSpPr>
          <p:spPr>
            <a:xfrm>
              <a:off x="335156" y="5604101"/>
              <a:ext cx="278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B90CB62-E99A-7C0F-5949-76A1F4D4042C}"/>
                </a:ext>
              </a:extLst>
            </p:cNvPr>
            <p:cNvSpPr txBox="1"/>
            <p:nvPr/>
          </p:nvSpPr>
          <p:spPr>
            <a:xfrm>
              <a:off x="373286" y="5952560"/>
              <a:ext cx="211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8E069A4-FB85-F057-376E-8A7D3793ECA3}"/>
                </a:ext>
              </a:extLst>
            </p:cNvPr>
            <p:cNvSpPr txBox="1"/>
            <p:nvPr/>
          </p:nvSpPr>
          <p:spPr>
            <a:xfrm>
              <a:off x="603217" y="6142603"/>
              <a:ext cx="211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38652BB-40EE-47AD-9F3B-6BDCF8E8592C}"/>
                </a:ext>
              </a:extLst>
            </p:cNvPr>
            <p:cNvSpPr txBox="1"/>
            <p:nvPr/>
          </p:nvSpPr>
          <p:spPr>
            <a:xfrm>
              <a:off x="1237689" y="6160028"/>
              <a:ext cx="278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039D94C-CD3B-F9A0-02E5-79E30CDFADE4}"/>
                </a:ext>
              </a:extLst>
            </p:cNvPr>
            <p:cNvSpPr txBox="1"/>
            <p:nvPr/>
          </p:nvSpPr>
          <p:spPr>
            <a:xfrm>
              <a:off x="1920085" y="6154952"/>
              <a:ext cx="278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957CDA9-F59A-4A4B-22C0-D711E79E2AEF}"/>
                </a:ext>
              </a:extLst>
            </p:cNvPr>
            <p:cNvSpPr txBox="1"/>
            <p:nvPr/>
          </p:nvSpPr>
          <p:spPr>
            <a:xfrm>
              <a:off x="2517975" y="6150355"/>
              <a:ext cx="278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BABB254-EE47-383F-FE72-18F728267B13}"/>
                </a:ext>
              </a:extLst>
            </p:cNvPr>
            <p:cNvSpPr txBox="1"/>
            <p:nvPr/>
          </p:nvSpPr>
          <p:spPr>
            <a:xfrm>
              <a:off x="1413770" y="6346301"/>
              <a:ext cx="539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D811DFEA-EE8D-14CD-3D8A-0700C29455F5}"/>
                </a:ext>
              </a:extLst>
            </p:cNvPr>
            <p:cNvSpPr/>
            <p:nvPr/>
          </p:nvSpPr>
          <p:spPr bwMode="auto">
            <a:xfrm>
              <a:off x="2535887" y="5497526"/>
              <a:ext cx="123578" cy="142621"/>
            </a:xfrm>
            <a:prstGeom prst="rect">
              <a:avLst/>
            </a:prstGeom>
            <a:solidFill>
              <a:srgbClr val="3E637D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EA5EC475-8987-F926-3340-074D9351A66F}"/>
                </a:ext>
              </a:extLst>
            </p:cNvPr>
            <p:cNvSpPr/>
            <p:nvPr/>
          </p:nvSpPr>
          <p:spPr bwMode="auto">
            <a:xfrm>
              <a:off x="2535886" y="5202207"/>
              <a:ext cx="123578" cy="142621"/>
            </a:xfrm>
            <a:prstGeom prst="rect">
              <a:avLst/>
            </a:prstGeom>
            <a:solidFill>
              <a:srgbClr val="90353A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5121275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950D765-C227-E07B-0D9F-438D701D63D8}"/>
                </a:ext>
              </a:extLst>
            </p:cNvPr>
            <p:cNvSpPr txBox="1"/>
            <p:nvPr/>
          </p:nvSpPr>
          <p:spPr>
            <a:xfrm>
              <a:off x="1982919" y="5477020"/>
              <a:ext cx="1138415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ROB 0-3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164E50A-1A93-3E2D-8C09-3156529F6FBB}"/>
                </a:ext>
              </a:extLst>
            </p:cNvPr>
            <p:cNvSpPr txBox="1"/>
            <p:nvPr/>
          </p:nvSpPr>
          <p:spPr>
            <a:xfrm>
              <a:off x="1967093" y="5175974"/>
              <a:ext cx="1138416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ROB 4-5</a:t>
              </a: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id="{17B1F3CA-3C4F-354A-DF6A-E71C09BFE805}"/>
                </a:ext>
              </a:extLst>
            </p:cNvPr>
            <p:cNvSpPr txBox="1"/>
            <p:nvPr/>
          </p:nvSpPr>
          <p:spPr>
            <a:xfrm>
              <a:off x="0" y="6357939"/>
              <a:ext cx="447118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mber at risk: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OB4-5  5             2               1           1              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OB0-3 13            2               1           1</a:t>
              </a:r>
            </a:p>
          </p:txBody>
        </p:sp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88C83E43-0788-A70B-DBE2-3FAB955A7DA1}"/>
                </a:ext>
              </a:extLst>
            </p:cNvPr>
            <p:cNvSpPr txBox="1"/>
            <p:nvPr/>
          </p:nvSpPr>
          <p:spPr>
            <a:xfrm>
              <a:off x="2103603" y="2679837"/>
              <a:ext cx="1138414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 = 0.625</a:t>
              </a:r>
            </a:p>
          </p:txBody>
        </p:sp>
        <p:sp>
          <p:nvSpPr>
            <p:cNvPr id="462" name="TextBox 461">
              <a:extLst>
                <a:ext uri="{FF2B5EF4-FFF2-40B4-BE49-F238E27FC236}">
                  <a16:creationId xmlns:a16="http://schemas.microsoft.com/office/drawing/2014/main" id="{7EAD1060-B199-A8B4-9881-FB0F1CADCAF4}"/>
                </a:ext>
              </a:extLst>
            </p:cNvPr>
            <p:cNvSpPr txBox="1"/>
            <p:nvPr/>
          </p:nvSpPr>
          <p:spPr>
            <a:xfrm>
              <a:off x="2095979" y="5711129"/>
              <a:ext cx="1138414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 = 0.111</a:t>
              </a:r>
            </a:p>
          </p:txBody>
        </p:sp>
        <p:sp>
          <p:nvSpPr>
            <p:cNvPr id="469" name="TextBox 468">
              <a:extLst>
                <a:ext uri="{FF2B5EF4-FFF2-40B4-BE49-F238E27FC236}">
                  <a16:creationId xmlns:a16="http://schemas.microsoft.com/office/drawing/2014/main" id="{F290DD6E-D667-D82A-9325-55193F762C52}"/>
                </a:ext>
              </a:extLst>
            </p:cNvPr>
            <p:cNvSpPr txBox="1"/>
            <p:nvPr/>
          </p:nvSpPr>
          <p:spPr>
            <a:xfrm>
              <a:off x="950753" y="782035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2%</a:t>
              </a:r>
            </a:p>
          </p:txBody>
        </p:sp>
        <p:sp>
          <p:nvSpPr>
            <p:cNvPr id="476" name="TextBox 475">
              <a:extLst>
                <a:ext uri="{FF2B5EF4-FFF2-40B4-BE49-F238E27FC236}">
                  <a16:creationId xmlns:a16="http://schemas.microsoft.com/office/drawing/2014/main" id="{3CEB5B52-66E5-8BBA-30E2-1ABD0378CE07}"/>
                </a:ext>
              </a:extLst>
            </p:cNvPr>
            <p:cNvSpPr txBox="1"/>
            <p:nvPr/>
          </p:nvSpPr>
          <p:spPr>
            <a:xfrm>
              <a:off x="1912189" y="876042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%</a:t>
              </a:r>
            </a:p>
          </p:txBody>
        </p:sp>
        <p:sp>
          <p:nvSpPr>
            <p:cNvPr id="483" name="TextBox 482">
              <a:extLst>
                <a:ext uri="{FF2B5EF4-FFF2-40B4-BE49-F238E27FC236}">
                  <a16:creationId xmlns:a16="http://schemas.microsoft.com/office/drawing/2014/main" id="{6FAE168E-DFEC-764E-90F4-D0678E09350D}"/>
                </a:ext>
              </a:extLst>
            </p:cNvPr>
            <p:cNvSpPr txBox="1"/>
            <p:nvPr/>
          </p:nvSpPr>
          <p:spPr>
            <a:xfrm>
              <a:off x="788070" y="1505371"/>
              <a:ext cx="1138414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N=23</a:t>
              </a:r>
            </a:p>
          </p:txBody>
        </p:sp>
        <p:sp>
          <p:nvSpPr>
            <p:cNvPr id="490" name="TextBox 489">
              <a:extLst>
                <a:ext uri="{FF2B5EF4-FFF2-40B4-BE49-F238E27FC236}">
                  <a16:creationId xmlns:a16="http://schemas.microsoft.com/office/drawing/2014/main" id="{2DB56EA7-3259-99BB-2749-448316F8E7C3}"/>
                </a:ext>
              </a:extLst>
            </p:cNvPr>
            <p:cNvSpPr txBox="1"/>
            <p:nvPr/>
          </p:nvSpPr>
          <p:spPr>
            <a:xfrm>
              <a:off x="1702429" y="1495058"/>
              <a:ext cx="1138414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N=23</a:t>
              </a:r>
            </a:p>
          </p:txBody>
        </p:sp>
        <p:sp>
          <p:nvSpPr>
            <p:cNvPr id="497" name="TextBox 496">
              <a:extLst>
                <a:ext uri="{FF2B5EF4-FFF2-40B4-BE49-F238E27FC236}">
                  <a16:creationId xmlns:a16="http://schemas.microsoft.com/office/drawing/2014/main" id="{945D9F7D-68DC-04E4-08FC-A30D8A5D88F4}"/>
                </a:ext>
              </a:extLst>
            </p:cNvPr>
            <p:cNvSpPr txBox="1"/>
            <p:nvPr/>
          </p:nvSpPr>
          <p:spPr>
            <a:xfrm>
              <a:off x="2388972" y="1485272"/>
              <a:ext cx="1138414" cy="279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0000"/>
                </a:lnSpc>
              </a:pPr>
              <a:r>
                <a:rPr lang="en-US" sz="1200" dirty="0">
                  <a:latin typeface="Arial"/>
                  <a:cs typeface="Arial"/>
                </a:rPr>
                <a:t>P=0.514</a:t>
              </a:r>
            </a:p>
          </p:txBody>
        </p:sp>
        <p:sp>
          <p:nvSpPr>
            <p:cNvPr id="504" name="TextBox 503">
              <a:extLst>
                <a:ext uri="{FF2B5EF4-FFF2-40B4-BE49-F238E27FC236}">
                  <a16:creationId xmlns:a16="http://schemas.microsoft.com/office/drawing/2014/main" id="{CD9EE12C-FD43-C954-0A1E-B95C3C3106B8}"/>
                </a:ext>
              </a:extLst>
            </p:cNvPr>
            <p:cNvSpPr txBox="1"/>
            <p:nvPr/>
          </p:nvSpPr>
          <p:spPr>
            <a:xfrm>
              <a:off x="-84801" y="1592297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11" name="TextBox 510">
              <a:extLst>
                <a:ext uri="{FF2B5EF4-FFF2-40B4-BE49-F238E27FC236}">
                  <a16:creationId xmlns:a16="http://schemas.microsoft.com/office/drawing/2014/main" id="{BE70FA90-2067-D5C7-C27D-A8DD6CEFFFFE}"/>
                </a:ext>
              </a:extLst>
            </p:cNvPr>
            <p:cNvSpPr txBox="1"/>
            <p:nvPr/>
          </p:nvSpPr>
          <p:spPr>
            <a:xfrm>
              <a:off x="-104993" y="4276457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257" name="TextBox 256">
            <a:extLst>
              <a:ext uri="{FF2B5EF4-FFF2-40B4-BE49-F238E27FC236}">
                <a16:creationId xmlns:a16="http://schemas.microsoft.com/office/drawing/2014/main" id="{8468A5C0-D48A-B729-FD62-440C859B46D1}"/>
              </a:ext>
            </a:extLst>
          </p:cNvPr>
          <p:cNvSpPr txBox="1"/>
          <p:nvPr/>
        </p:nvSpPr>
        <p:spPr>
          <a:xfrm>
            <a:off x="-47011" y="9415878"/>
            <a:ext cx="37176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ankner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</a:t>
            </a:r>
          </a:p>
        </p:txBody>
      </p:sp>
    </p:spTree>
    <p:extLst>
      <p:ext uri="{BB962C8B-B14F-4D97-AF65-F5344CB8AC3E}">
        <p14:creationId xmlns:p14="http://schemas.microsoft.com/office/powerpoint/2010/main" val="1505228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2</TotalTime>
  <Words>225</Words>
  <Application>Microsoft Macintosh PowerPoint</Application>
  <PresentationFormat>Custom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-Maria Lazaratos</dc:creator>
  <cp:lastModifiedBy>Matthew Dankner</cp:lastModifiedBy>
  <cp:revision>203</cp:revision>
  <dcterms:created xsi:type="dcterms:W3CDTF">2022-07-03T02:50:13Z</dcterms:created>
  <dcterms:modified xsi:type="dcterms:W3CDTF">2023-06-15T19:09:06Z</dcterms:modified>
</cp:coreProperties>
</file>